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87" d="100"/>
          <a:sy n="87" d="100"/>
        </p:scale>
        <p:origin x="1494" y="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dkleftog:Desktop:my_temp_papers:ESA:Additional_analysis:Figures_revision:Figure_6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7365527806878"/>
          <c:y val="0.14081162931556601"/>
          <c:w val="0.79382334718889702"/>
          <c:h val="0.68822050806997503"/>
        </c:manualLayout>
      </c:layout>
      <c:areaChart>
        <c:grouping val="standard"/>
        <c:varyColors val="0"/>
        <c:ser>
          <c:idx val="0"/>
          <c:order val="0"/>
          <c:tx>
            <c:v>PPV</c:v>
          </c:tx>
          <c:spPr>
            <a:solidFill>
              <a:schemeClr val="accent6">
                <a:lumMod val="40000"/>
                <a:lumOff val="60000"/>
              </a:schemeClr>
            </a:solidFill>
            <a:ln w="12700">
              <a:solidFill>
                <a:schemeClr val="tx1"/>
              </a:solidFill>
            </a:ln>
            <a:effectLst/>
            <a:scene3d>
              <a:camera prst="orthographicFront"/>
              <a:lightRig rig="threePt" dir="t"/>
            </a:scene3d>
            <a:sp3d prstMaterial="metal">
              <a:bevelT w="63500"/>
            </a:sp3d>
          </c:spPr>
          <c:cat>
            <c:strRef>
              <c:f>Sheet1!$A$2:$A$97</c:f>
              <c:strCache>
                <c:ptCount val="96"/>
                <c:pt idx="0">
                  <c:v>smooth muscle cell of trachea</c:v>
                </c:pt>
                <c:pt idx="1">
                  <c:v>smooth muscle tissue</c:v>
                </c:pt>
                <c:pt idx="2">
                  <c:v>fibroblast of tunica adventitia of artery</c:v>
                </c:pt>
                <c:pt idx="3">
                  <c:v>tongue</c:v>
                </c:pt>
                <c:pt idx="4">
                  <c:v>stomach</c:v>
                </c:pt>
                <c:pt idx="5">
                  <c:v>trabecular meshwork cell</c:v>
                </c:pt>
                <c:pt idx="6">
                  <c:v>uterine smooth muscle cell</c:v>
                </c:pt>
                <c:pt idx="7">
                  <c:v>vagina</c:v>
                </c:pt>
                <c:pt idx="8">
                  <c:v>cardiac myocyte</c:v>
                </c:pt>
                <c:pt idx="9">
                  <c:v>parotid gland</c:v>
                </c:pt>
                <c:pt idx="10">
                  <c:v>umbilical cord</c:v>
                </c:pt>
                <c:pt idx="11">
                  <c:v>fibroblast of choroid plexus</c:v>
                </c:pt>
                <c:pt idx="12">
                  <c:v>esophagus</c:v>
                </c:pt>
                <c:pt idx="13">
                  <c:v>smooth muscle cell of prostate</c:v>
                </c:pt>
                <c:pt idx="14">
                  <c:v>blood vessel</c:v>
                </c:pt>
                <c:pt idx="15">
                  <c:v>adipose tissue</c:v>
                </c:pt>
                <c:pt idx="16">
                  <c:v>gallbladder</c:v>
                </c:pt>
                <c:pt idx="17">
                  <c:v>uterus</c:v>
                </c:pt>
                <c:pt idx="18">
                  <c:v>pericyte cell</c:v>
                </c:pt>
                <c:pt idx="19">
                  <c:v>heart</c:v>
                </c:pt>
                <c:pt idx="20">
                  <c:v>testis</c:v>
                </c:pt>
                <c:pt idx="21">
                  <c:v>lens epithelial cell</c:v>
                </c:pt>
                <c:pt idx="22">
                  <c:v>neuronal stem cell</c:v>
                </c:pt>
                <c:pt idx="23">
                  <c:v>circulating cell</c:v>
                </c:pt>
                <c:pt idx="24">
                  <c:v>penis</c:v>
                </c:pt>
                <c:pt idx="25">
                  <c:v>mast cell</c:v>
                </c:pt>
                <c:pt idx="26">
                  <c:v>large intestine</c:v>
                </c:pt>
                <c:pt idx="27">
                  <c:v>enteric smooth muscle cell</c:v>
                </c:pt>
                <c:pt idx="28">
                  <c:v>fibroblast of gingiva</c:v>
                </c:pt>
                <c:pt idx="29">
                  <c:v>endothelial cell of lymphatic vessel</c:v>
                </c:pt>
                <c:pt idx="30">
                  <c:v>throat</c:v>
                </c:pt>
                <c:pt idx="31">
                  <c:v>natural killer cell</c:v>
                </c:pt>
                <c:pt idx="32">
                  <c:v>female gonad</c:v>
                </c:pt>
                <c:pt idx="33">
                  <c:v>myoblast</c:v>
                </c:pt>
                <c:pt idx="34">
                  <c:v>eye</c:v>
                </c:pt>
                <c:pt idx="35">
                  <c:v>pancreas</c:v>
                </c:pt>
                <c:pt idx="36">
                  <c:v>ciliated epithelial cell</c:v>
                </c:pt>
                <c:pt idx="37">
                  <c:v>T cell</c:v>
                </c:pt>
                <c:pt idx="38">
                  <c:v>neuron</c:v>
                </c:pt>
                <c:pt idx="39">
                  <c:v>epithelial cell of Malassez</c:v>
                </c:pt>
                <c:pt idx="40">
                  <c:v>hair follicle cell</c:v>
                </c:pt>
                <c:pt idx="41">
                  <c:v>amniotic epithelial cell</c:v>
                </c:pt>
                <c:pt idx="42">
                  <c:v>neutrophil</c:v>
                </c:pt>
                <c:pt idx="43">
                  <c:v>spleen</c:v>
                </c:pt>
                <c:pt idx="44">
                  <c:v>chondrocyte</c:v>
                </c:pt>
                <c:pt idx="45">
                  <c:v>salivary gland</c:v>
                </c:pt>
                <c:pt idx="46">
                  <c:v>mesenchymal cell</c:v>
                </c:pt>
                <c:pt idx="47">
                  <c:v>fat cell</c:v>
                </c:pt>
                <c:pt idx="48">
                  <c:v>tendon cell</c:v>
                </c:pt>
                <c:pt idx="49">
                  <c:v>acinar cell</c:v>
                </c:pt>
                <c:pt idx="50">
                  <c:v>endothelial cell of hepatic sinusoid</c:v>
                </c:pt>
                <c:pt idx="51">
                  <c:v>skeletal muscle tissue</c:v>
                </c:pt>
                <c:pt idx="52">
                  <c:v>keratinocyte</c:v>
                </c:pt>
                <c:pt idx="53">
                  <c:v>mammary epithelial cell</c:v>
                </c:pt>
                <c:pt idx="54">
                  <c:v>monocyte</c:v>
                </c:pt>
                <c:pt idx="55">
                  <c:v>stromal cell</c:v>
                </c:pt>
                <c:pt idx="56">
                  <c:v>kidney</c:v>
                </c:pt>
                <c:pt idx="57">
                  <c:v>vascular associated smooth muscle cell</c:v>
                </c:pt>
                <c:pt idx="58">
                  <c:v>thymus</c:v>
                </c:pt>
                <c:pt idx="59">
                  <c:v>melanocyte</c:v>
                </c:pt>
                <c:pt idx="60">
                  <c:v>hepatocyte</c:v>
                </c:pt>
                <c:pt idx="61">
                  <c:v>brain</c:v>
                </c:pt>
                <c:pt idx="62">
                  <c:v>meninx</c:v>
                </c:pt>
                <c:pt idx="63">
                  <c:v>hepatic stellate cell</c:v>
                </c:pt>
                <c:pt idx="64">
                  <c:v>small intestine</c:v>
                </c:pt>
                <c:pt idx="65">
                  <c:v>cardiac fibroblast</c:v>
                </c:pt>
                <c:pt idx="66">
                  <c:v>sensory epithelial cell</c:v>
                </c:pt>
                <c:pt idx="67">
                  <c:v>liver</c:v>
                </c:pt>
                <c:pt idx="68">
                  <c:v>macrophage</c:v>
                </c:pt>
                <c:pt idx="69">
                  <c:v>placenta</c:v>
                </c:pt>
                <c:pt idx="70">
                  <c:v>fibroblast of lymphatic vessel</c:v>
                </c:pt>
                <c:pt idx="71">
                  <c:v>tonsil</c:v>
                </c:pt>
                <c:pt idx="72">
                  <c:v>retinal pigment epithelial cell</c:v>
                </c:pt>
                <c:pt idx="73">
                  <c:v>internal male genitalia</c:v>
                </c:pt>
                <c:pt idx="74">
                  <c:v>iris pigment epithelial cell</c:v>
                </c:pt>
                <c:pt idx="75">
                  <c:v>placental epithelial cell</c:v>
                </c:pt>
                <c:pt idx="76">
                  <c:v>intestinal epithelial cell</c:v>
                </c:pt>
                <c:pt idx="77">
                  <c:v>spinal cord</c:v>
                </c:pt>
                <c:pt idx="78">
                  <c:v>osteoblast</c:v>
                </c:pt>
                <c:pt idx="79">
                  <c:v>dendritic cell</c:v>
                </c:pt>
                <c:pt idx="80">
                  <c:v>reticulocyte</c:v>
                </c:pt>
                <c:pt idx="81">
                  <c:v>skeletal muscle cell</c:v>
                </c:pt>
                <c:pt idx="82">
                  <c:v>epithelial cell of prostate</c:v>
                </c:pt>
                <c:pt idx="83">
                  <c:v>gingival epithelial cell</c:v>
                </c:pt>
                <c:pt idx="84">
                  <c:v>mesothelial cell</c:v>
                </c:pt>
                <c:pt idx="85">
                  <c:v>blood vessel endothelial cell</c:v>
                </c:pt>
                <c:pt idx="86">
                  <c:v>lymphocyte of B lineage</c:v>
                </c:pt>
                <c:pt idx="87">
                  <c:v>lung</c:v>
                </c:pt>
                <c:pt idx="88">
                  <c:v>thyroid gland</c:v>
                </c:pt>
                <c:pt idx="89">
                  <c:v>preadipocyte</c:v>
                </c:pt>
                <c:pt idx="90">
                  <c:v>respiratory epithelial cell</c:v>
                </c:pt>
                <c:pt idx="91">
                  <c:v>urothelial cell</c:v>
                </c:pt>
                <c:pt idx="92">
                  <c:v>astrocyte</c:v>
                </c:pt>
                <c:pt idx="93">
                  <c:v>blood</c:v>
                </c:pt>
                <c:pt idx="94">
                  <c:v>skin fibroblast</c:v>
                </c:pt>
                <c:pt idx="95">
                  <c:v>kidney epithelial cell</c:v>
                </c:pt>
              </c:strCache>
            </c:strRef>
          </c:cat>
          <c:val>
            <c:numRef>
              <c:f>Sheet1!$B$2:$B$97</c:f>
              <c:numCache>
                <c:formatCode>General</c:formatCode>
                <c:ptCount val="96"/>
                <c:pt idx="0">
                  <c:v>93.532183304910603</c:v>
                </c:pt>
                <c:pt idx="1">
                  <c:v>90.025601638504739</c:v>
                </c:pt>
                <c:pt idx="2">
                  <c:v>88.766001024065602</c:v>
                </c:pt>
                <c:pt idx="3">
                  <c:v>88.238095238095198</c:v>
                </c:pt>
                <c:pt idx="4">
                  <c:v>87.839002267573662</c:v>
                </c:pt>
                <c:pt idx="5">
                  <c:v>83.997493734335904</c:v>
                </c:pt>
                <c:pt idx="6">
                  <c:v>83.678918169209354</c:v>
                </c:pt>
                <c:pt idx="7">
                  <c:v>83.622283865002302</c:v>
                </c:pt>
                <c:pt idx="8">
                  <c:v>80.782312925170103</c:v>
                </c:pt>
                <c:pt idx="9">
                  <c:v>79.513403263403205</c:v>
                </c:pt>
                <c:pt idx="10">
                  <c:v>78.950917909251203</c:v>
                </c:pt>
                <c:pt idx="11">
                  <c:v>78.834151959151882</c:v>
                </c:pt>
                <c:pt idx="12">
                  <c:v>77.223851417399757</c:v>
                </c:pt>
                <c:pt idx="13">
                  <c:v>77.220724767894581</c:v>
                </c:pt>
                <c:pt idx="14">
                  <c:v>75.776699029126206</c:v>
                </c:pt>
                <c:pt idx="15">
                  <c:v>75.571802663148802</c:v>
                </c:pt>
                <c:pt idx="16">
                  <c:v>75.15144772154116</c:v>
                </c:pt>
                <c:pt idx="17">
                  <c:v>73.917378052892062</c:v>
                </c:pt>
                <c:pt idx="18">
                  <c:v>72.392510402219202</c:v>
                </c:pt>
                <c:pt idx="19">
                  <c:v>72.091597616830782</c:v>
                </c:pt>
                <c:pt idx="20">
                  <c:v>71.544391752192979</c:v>
                </c:pt>
                <c:pt idx="21">
                  <c:v>70.969862934115298</c:v>
                </c:pt>
                <c:pt idx="22">
                  <c:v>70.905141364488557</c:v>
                </c:pt>
                <c:pt idx="23">
                  <c:v>70.32687006873806</c:v>
                </c:pt>
                <c:pt idx="24">
                  <c:v>69.48623775751436</c:v>
                </c:pt>
                <c:pt idx="25">
                  <c:v>69.415804787622207</c:v>
                </c:pt>
                <c:pt idx="26">
                  <c:v>69.109861491875506</c:v>
                </c:pt>
                <c:pt idx="27">
                  <c:v>68.165599927725893</c:v>
                </c:pt>
                <c:pt idx="28">
                  <c:v>67.968868276585056</c:v>
                </c:pt>
                <c:pt idx="29">
                  <c:v>67.959095122665858</c:v>
                </c:pt>
                <c:pt idx="30">
                  <c:v>67.571497285782982</c:v>
                </c:pt>
                <c:pt idx="31">
                  <c:v>67.546363571762498</c:v>
                </c:pt>
                <c:pt idx="32">
                  <c:v>66.947791164658582</c:v>
                </c:pt>
                <c:pt idx="33">
                  <c:v>65.742360417360402</c:v>
                </c:pt>
                <c:pt idx="34">
                  <c:v>65.615827819974157</c:v>
                </c:pt>
                <c:pt idx="35">
                  <c:v>65.395735808102458</c:v>
                </c:pt>
                <c:pt idx="36">
                  <c:v>65.349225990759393</c:v>
                </c:pt>
                <c:pt idx="37">
                  <c:v>64.878797207152914</c:v>
                </c:pt>
                <c:pt idx="38">
                  <c:v>64.818718918712293</c:v>
                </c:pt>
                <c:pt idx="39">
                  <c:v>64.732979133748756</c:v>
                </c:pt>
                <c:pt idx="40">
                  <c:v>64.527772195012659</c:v>
                </c:pt>
                <c:pt idx="41">
                  <c:v>64.298795700664854</c:v>
                </c:pt>
                <c:pt idx="42">
                  <c:v>63.914134843080703</c:v>
                </c:pt>
                <c:pt idx="43">
                  <c:v>63.569009772364581</c:v>
                </c:pt>
                <c:pt idx="44">
                  <c:v>63.11659189861048</c:v>
                </c:pt>
                <c:pt idx="45">
                  <c:v>63.046684615312039</c:v>
                </c:pt>
                <c:pt idx="46">
                  <c:v>62.913050415383672</c:v>
                </c:pt>
                <c:pt idx="47">
                  <c:v>62.371944566338968</c:v>
                </c:pt>
                <c:pt idx="48">
                  <c:v>61.899068819681197</c:v>
                </c:pt>
                <c:pt idx="49">
                  <c:v>61.796862589206</c:v>
                </c:pt>
                <c:pt idx="50">
                  <c:v>61.2200371321563</c:v>
                </c:pt>
                <c:pt idx="51">
                  <c:v>61.1101476021568</c:v>
                </c:pt>
                <c:pt idx="52">
                  <c:v>60.896106361563803</c:v>
                </c:pt>
                <c:pt idx="53">
                  <c:v>60.888523350672692</c:v>
                </c:pt>
                <c:pt idx="54">
                  <c:v>60.749146764272403</c:v>
                </c:pt>
                <c:pt idx="55">
                  <c:v>60.603596763659098</c:v>
                </c:pt>
                <c:pt idx="56">
                  <c:v>59.966591004204297</c:v>
                </c:pt>
                <c:pt idx="57">
                  <c:v>59.8741596313317</c:v>
                </c:pt>
                <c:pt idx="58">
                  <c:v>59.855777963692042</c:v>
                </c:pt>
                <c:pt idx="59">
                  <c:v>59.604171585018797</c:v>
                </c:pt>
                <c:pt idx="60">
                  <c:v>59.525706601987402</c:v>
                </c:pt>
                <c:pt idx="61">
                  <c:v>59.525096198590902</c:v>
                </c:pt>
                <c:pt idx="62">
                  <c:v>59.461649378987197</c:v>
                </c:pt>
                <c:pt idx="63">
                  <c:v>59.072759994775097</c:v>
                </c:pt>
                <c:pt idx="64">
                  <c:v>59.043985859240067</c:v>
                </c:pt>
                <c:pt idx="65">
                  <c:v>58.395459270976801</c:v>
                </c:pt>
                <c:pt idx="66">
                  <c:v>58.365618525124702</c:v>
                </c:pt>
                <c:pt idx="67">
                  <c:v>58.221164197058201</c:v>
                </c:pt>
                <c:pt idx="68">
                  <c:v>58.178687731725198</c:v>
                </c:pt>
                <c:pt idx="69">
                  <c:v>58.080317156637371</c:v>
                </c:pt>
                <c:pt idx="70">
                  <c:v>57.917738631210369</c:v>
                </c:pt>
                <c:pt idx="71">
                  <c:v>57.860396994168902</c:v>
                </c:pt>
                <c:pt idx="72">
                  <c:v>57.855283439733867</c:v>
                </c:pt>
                <c:pt idx="73">
                  <c:v>57.499630927492497</c:v>
                </c:pt>
                <c:pt idx="74">
                  <c:v>57.307874936076097</c:v>
                </c:pt>
                <c:pt idx="75">
                  <c:v>57.249745628017997</c:v>
                </c:pt>
                <c:pt idx="76">
                  <c:v>57.24406387989098</c:v>
                </c:pt>
                <c:pt idx="77">
                  <c:v>57.136828952726503</c:v>
                </c:pt>
                <c:pt idx="78">
                  <c:v>57.09749795792748</c:v>
                </c:pt>
                <c:pt idx="79">
                  <c:v>56.976793823961799</c:v>
                </c:pt>
                <c:pt idx="80">
                  <c:v>56.960086905398803</c:v>
                </c:pt>
                <c:pt idx="81">
                  <c:v>56.94347337460708</c:v>
                </c:pt>
                <c:pt idx="82">
                  <c:v>56.928128286796401</c:v>
                </c:pt>
                <c:pt idx="83">
                  <c:v>56.770624575290661</c:v>
                </c:pt>
                <c:pt idx="84">
                  <c:v>56.463442367094203</c:v>
                </c:pt>
                <c:pt idx="85">
                  <c:v>56.409481112639703</c:v>
                </c:pt>
                <c:pt idx="86">
                  <c:v>56.191777232767002</c:v>
                </c:pt>
                <c:pt idx="87">
                  <c:v>56.179429263254796</c:v>
                </c:pt>
                <c:pt idx="88">
                  <c:v>55.737453567539703</c:v>
                </c:pt>
                <c:pt idx="89">
                  <c:v>55.543330552853597</c:v>
                </c:pt>
                <c:pt idx="90">
                  <c:v>55.150950765721603</c:v>
                </c:pt>
                <c:pt idx="91">
                  <c:v>55.091392405080697</c:v>
                </c:pt>
                <c:pt idx="92">
                  <c:v>55.049519994472902</c:v>
                </c:pt>
                <c:pt idx="93">
                  <c:v>54.755947785568999</c:v>
                </c:pt>
                <c:pt idx="94">
                  <c:v>54.503634250045103</c:v>
                </c:pt>
                <c:pt idx="95">
                  <c:v>53.651366774434592</c:v>
                </c:pt>
              </c:numCache>
            </c:numRef>
          </c:val>
        </c:ser>
        <c:ser>
          <c:idx val="1"/>
          <c:order val="1"/>
          <c:tx>
            <c:v>GM</c:v>
          </c:tx>
          <c:spPr>
            <a:solidFill>
              <a:schemeClr val="accent5">
                <a:lumMod val="40000"/>
                <a:lumOff val="60000"/>
              </a:schemeClr>
            </a:solidFill>
            <a:ln>
              <a:solidFill>
                <a:schemeClr val="tx1"/>
              </a:solidFill>
            </a:ln>
          </c:spPr>
          <c:dPt>
            <c:idx val="0"/>
            <c:bubble3D val="0"/>
          </c:dPt>
          <c:cat>
            <c:strRef>
              <c:f>Sheet1!$A$2:$A$97</c:f>
              <c:strCache>
                <c:ptCount val="96"/>
                <c:pt idx="0">
                  <c:v>smooth muscle cell of trachea</c:v>
                </c:pt>
                <c:pt idx="1">
                  <c:v>smooth muscle tissue</c:v>
                </c:pt>
                <c:pt idx="2">
                  <c:v>fibroblast of tunica adventitia of artery</c:v>
                </c:pt>
                <c:pt idx="3">
                  <c:v>tongue</c:v>
                </c:pt>
                <c:pt idx="4">
                  <c:v>stomach</c:v>
                </c:pt>
                <c:pt idx="5">
                  <c:v>trabecular meshwork cell</c:v>
                </c:pt>
                <c:pt idx="6">
                  <c:v>uterine smooth muscle cell</c:v>
                </c:pt>
                <c:pt idx="7">
                  <c:v>vagina</c:v>
                </c:pt>
                <c:pt idx="8">
                  <c:v>cardiac myocyte</c:v>
                </c:pt>
                <c:pt idx="9">
                  <c:v>parotid gland</c:v>
                </c:pt>
                <c:pt idx="10">
                  <c:v>umbilical cord</c:v>
                </c:pt>
                <c:pt idx="11">
                  <c:v>fibroblast of choroid plexus</c:v>
                </c:pt>
                <c:pt idx="12">
                  <c:v>esophagus</c:v>
                </c:pt>
                <c:pt idx="13">
                  <c:v>smooth muscle cell of prostate</c:v>
                </c:pt>
                <c:pt idx="14">
                  <c:v>blood vessel</c:v>
                </c:pt>
                <c:pt idx="15">
                  <c:v>adipose tissue</c:v>
                </c:pt>
                <c:pt idx="16">
                  <c:v>gallbladder</c:v>
                </c:pt>
                <c:pt idx="17">
                  <c:v>uterus</c:v>
                </c:pt>
                <c:pt idx="18">
                  <c:v>pericyte cell</c:v>
                </c:pt>
                <c:pt idx="19">
                  <c:v>heart</c:v>
                </c:pt>
                <c:pt idx="20">
                  <c:v>testis</c:v>
                </c:pt>
                <c:pt idx="21">
                  <c:v>lens epithelial cell</c:v>
                </c:pt>
                <c:pt idx="22">
                  <c:v>neuronal stem cell</c:v>
                </c:pt>
                <c:pt idx="23">
                  <c:v>circulating cell</c:v>
                </c:pt>
                <c:pt idx="24">
                  <c:v>penis</c:v>
                </c:pt>
                <c:pt idx="25">
                  <c:v>mast cell</c:v>
                </c:pt>
                <c:pt idx="26">
                  <c:v>large intestine</c:v>
                </c:pt>
                <c:pt idx="27">
                  <c:v>enteric smooth muscle cell</c:v>
                </c:pt>
                <c:pt idx="28">
                  <c:v>fibroblast of gingiva</c:v>
                </c:pt>
                <c:pt idx="29">
                  <c:v>endothelial cell of lymphatic vessel</c:v>
                </c:pt>
                <c:pt idx="30">
                  <c:v>throat</c:v>
                </c:pt>
                <c:pt idx="31">
                  <c:v>natural killer cell</c:v>
                </c:pt>
                <c:pt idx="32">
                  <c:v>female gonad</c:v>
                </c:pt>
                <c:pt idx="33">
                  <c:v>myoblast</c:v>
                </c:pt>
                <c:pt idx="34">
                  <c:v>eye</c:v>
                </c:pt>
                <c:pt idx="35">
                  <c:v>pancreas</c:v>
                </c:pt>
                <c:pt idx="36">
                  <c:v>ciliated epithelial cell</c:v>
                </c:pt>
                <c:pt idx="37">
                  <c:v>T cell</c:v>
                </c:pt>
                <c:pt idx="38">
                  <c:v>neuron</c:v>
                </c:pt>
                <c:pt idx="39">
                  <c:v>epithelial cell of Malassez</c:v>
                </c:pt>
                <c:pt idx="40">
                  <c:v>hair follicle cell</c:v>
                </c:pt>
                <c:pt idx="41">
                  <c:v>amniotic epithelial cell</c:v>
                </c:pt>
                <c:pt idx="42">
                  <c:v>neutrophil</c:v>
                </c:pt>
                <c:pt idx="43">
                  <c:v>spleen</c:v>
                </c:pt>
                <c:pt idx="44">
                  <c:v>chondrocyte</c:v>
                </c:pt>
                <c:pt idx="45">
                  <c:v>salivary gland</c:v>
                </c:pt>
                <c:pt idx="46">
                  <c:v>mesenchymal cell</c:v>
                </c:pt>
                <c:pt idx="47">
                  <c:v>fat cell</c:v>
                </c:pt>
                <c:pt idx="48">
                  <c:v>tendon cell</c:v>
                </c:pt>
                <c:pt idx="49">
                  <c:v>acinar cell</c:v>
                </c:pt>
                <c:pt idx="50">
                  <c:v>endothelial cell of hepatic sinusoid</c:v>
                </c:pt>
                <c:pt idx="51">
                  <c:v>skeletal muscle tissue</c:v>
                </c:pt>
                <c:pt idx="52">
                  <c:v>keratinocyte</c:v>
                </c:pt>
                <c:pt idx="53">
                  <c:v>mammary epithelial cell</c:v>
                </c:pt>
                <c:pt idx="54">
                  <c:v>monocyte</c:v>
                </c:pt>
                <c:pt idx="55">
                  <c:v>stromal cell</c:v>
                </c:pt>
                <c:pt idx="56">
                  <c:v>kidney</c:v>
                </c:pt>
                <c:pt idx="57">
                  <c:v>vascular associated smooth muscle cell</c:v>
                </c:pt>
                <c:pt idx="58">
                  <c:v>thymus</c:v>
                </c:pt>
                <c:pt idx="59">
                  <c:v>melanocyte</c:v>
                </c:pt>
                <c:pt idx="60">
                  <c:v>hepatocyte</c:v>
                </c:pt>
                <c:pt idx="61">
                  <c:v>brain</c:v>
                </c:pt>
                <c:pt idx="62">
                  <c:v>meninx</c:v>
                </c:pt>
                <c:pt idx="63">
                  <c:v>hepatic stellate cell</c:v>
                </c:pt>
                <c:pt idx="64">
                  <c:v>small intestine</c:v>
                </c:pt>
                <c:pt idx="65">
                  <c:v>cardiac fibroblast</c:v>
                </c:pt>
                <c:pt idx="66">
                  <c:v>sensory epithelial cell</c:v>
                </c:pt>
                <c:pt idx="67">
                  <c:v>liver</c:v>
                </c:pt>
                <c:pt idx="68">
                  <c:v>macrophage</c:v>
                </c:pt>
                <c:pt idx="69">
                  <c:v>placenta</c:v>
                </c:pt>
                <c:pt idx="70">
                  <c:v>fibroblast of lymphatic vessel</c:v>
                </c:pt>
                <c:pt idx="71">
                  <c:v>tonsil</c:v>
                </c:pt>
                <c:pt idx="72">
                  <c:v>retinal pigment epithelial cell</c:v>
                </c:pt>
                <c:pt idx="73">
                  <c:v>internal male genitalia</c:v>
                </c:pt>
                <c:pt idx="74">
                  <c:v>iris pigment epithelial cell</c:v>
                </c:pt>
                <c:pt idx="75">
                  <c:v>placental epithelial cell</c:v>
                </c:pt>
                <c:pt idx="76">
                  <c:v>intestinal epithelial cell</c:v>
                </c:pt>
                <c:pt idx="77">
                  <c:v>spinal cord</c:v>
                </c:pt>
                <c:pt idx="78">
                  <c:v>osteoblast</c:v>
                </c:pt>
                <c:pt idx="79">
                  <c:v>dendritic cell</c:v>
                </c:pt>
                <c:pt idx="80">
                  <c:v>reticulocyte</c:v>
                </c:pt>
                <c:pt idx="81">
                  <c:v>skeletal muscle cell</c:v>
                </c:pt>
                <c:pt idx="82">
                  <c:v>epithelial cell of prostate</c:v>
                </c:pt>
                <c:pt idx="83">
                  <c:v>gingival epithelial cell</c:v>
                </c:pt>
                <c:pt idx="84">
                  <c:v>mesothelial cell</c:v>
                </c:pt>
                <c:pt idx="85">
                  <c:v>blood vessel endothelial cell</c:v>
                </c:pt>
                <c:pt idx="86">
                  <c:v>lymphocyte of B lineage</c:v>
                </c:pt>
                <c:pt idx="87">
                  <c:v>lung</c:v>
                </c:pt>
                <c:pt idx="88">
                  <c:v>thyroid gland</c:v>
                </c:pt>
                <c:pt idx="89">
                  <c:v>preadipocyte</c:v>
                </c:pt>
                <c:pt idx="90">
                  <c:v>respiratory epithelial cell</c:v>
                </c:pt>
                <c:pt idx="91">
                  <c:v>urothelial cell</c:v>
                </c:pt>
                <c:pt idx="92">
                  <c:v>astrocyte</c:v>
                </c:pt>
                <c:pt idx="93">
                  <c:v>blood</c:v>
                </c:pt>
                <c:pt idx="94">
                  <c:v>skin fibroblast</c:v>
                </c:pt>
                <c:pt idx="95">
                  <c:v>kidney epithelial cell</c:v>
                </c:pt>
              </c:strCache>
            </c:strRef>
          </c:cat>
          <c:val>
            <c:numRef>
              <c:f>Sheet1!$E$2:$E$97</c:f>
              <c:numCache>
                <c:formatCode>General</c:formatCode>
                <c:ptCount val="96"/>
                <c:pt idx="0">
                  <c:v>83.991409429143701</c:v>
                </c:pt>
                <c:pt idx="1">
                  <c:v>79.759321126174001</c:v>
                </c:pt>
                <c:pt idx="2">
                  <c:v>72.946066644658799</c:v>
                </c:pt>
                <c:pt idx="3">
                  <c:v>82.449326393860872</c:v>
                </c:pt>
                <c:pt idx="4">
                  <c:v>81.281209932063121</c:v>
                </c:pt>
                <c:pt idx="5">
                  <c:v>75.941764131467764</c:v>
                </c:pt>
                <c:pt idx="6">
                  <c:v>78.009501959544792</c:v>
                </c:pt>
                <c:pt idx="7">
                  <c:v>71.615813084382665</c:v>
                </c:pt>
                <c:pt idx="8">
                  <c:v>63.885114622816261</c:v>
                </c:pt>
                <c:pt idx="9">
                  <c:v>71.655081687175453</c:v>
                </c:pt>
                <c:pt idx="10">
                  <c:v>72.439698020105098</c:v>
                </c:pt>
                <c:pt idx="11">
                  <c:v>73.264922323569081</c:v>
                </c:pt>
                <c:pt idx="12">
                  <c:v>60.804908678980347</c:v>
                </c:pt>
                <c:pt idx="13">
                  <c:v>71.460754699329698</c:v>
                </c:pt>
                <c:pt idx="14">
                  <c:v>66.745546969921364</c:v>
                </c:pt>
                <c:pt idx="15">
                  <c:v>64.640882001259854</c:v>
                </c:pt>
                <c:pt idx="16">
                  <c:v>68.090579261772106</c:v>
                </c:pt>
                <c:pt idx="17">
                  <c:v>70.605378962384904</c:v>
                </c:pt>
                <c:pt idx="18">
                  <c:v>65.889091006567185</c:v>
                </c:pt>
                <c:pt idx="19">
                  <c:v>65.799140055935865</c:v>
                </c:pt>
                <c:pt idx="20">
                  <c:v>70.582736017161423</c:v>
                </c:pt>
                <c:pt idx="21">
                  <c:v>60.332774673238639</c:v>
                </c:pt>
                <c:pt idx="22">
                  <c:v>68.11467847239831</c:v>
                </c:pt>
                <c:pt idx="23">
                  <c:v>70.389183488365205</c:v>
                </c:pt>
                <c:pt idx="24">
                  <c:v>62.612079432446997</c:v>
                </c:pt>
                <c:pt idx="25">
                  <c:v>68.316558709346893</c:v>
                </c:pt>
                <c:pt idx="26">
                  <c:v>60.673377710800928</c:v>
                </c:pt>
                <c:pt idx="27">
                  <c:v>66.179463031802456</c:v>
                </c:pt>
                <c:pt idx="28">
                  <c:v>62.285527011069767</c:v>
                </c:pt>
                <c:pt idx="29">
                  <c:v>66.60200054999585</c:v>
                </c:pt>
                <c:pt idx="30">
                  <c:v>65.901716544876223</c:v>
                </c:pt>
                <c:pt idx="31">
                  <c:v>66.092089088089523</c:v>
                </c:pt>
                <c:pt idx="32">
                  <c:v>63.294936980783127</c:v>
                </c:pt>
                <c:pt idx="33">
                  <c:v>59.651023371221783</c:v>
                </c:pt>
                <c:pt idx="34">
                  <c:v>63.402975053608422</c:v>
                </c:pt>
                <c:pt idx="35">
                  <c:v>60.563350626513241</c:v>
                </c:pt>
                <c:pt idx="36">
                  <c:v>63.060859532341333</c:v>
                </c:pt>
                <c:pt idx="37">
                  <c:v>63.390888620558677</c:v>
                </c:pt>
                <c:pt idx="38">
                  <c:v>64.437720966923294</c:v>
                </c:pt>
                <c:pt idx="39">
                  <c:v>62.930352727687897</c:v>
                </c:pt>
                <c:pt idx="40">
                  <c:v>62.76990756004168</c:v>
                </c:pt>
                <c:pt idx="41">
                  <c:v>58.484455278505301</c:v>
                </c:pt>
                <c:pt idx="42">
                  <c:v>61.767854124777578</c:v>
                </c:pt>
                <c:pt idx="43">
                  <c:v>61.131443972642742</c:v>
                </c:pt>
                <c:pt idx="44">
                  <c:v>62.1123399301188</c:v>
                </c:pt>
                <c:pt idx="45">
                  <c:v>60.300313534923177</c:v>
                </c:pt>
                <c:pt idx="46">
                  <c:v>58.1355740790273</c:v>
                </c:pt>
                <c:pt idx="47">
                  <c:v>61.62480559953503</c:v>
                </c:pt>
                <c:pt idx="48">
                  <c:v>60.04062226486608</c:v>
                </c:pt>
                <c:pt idx="49">
                  <c:v>57.813002644175498</c:v>
                </c:pt>
                <c:pt idx="50">
                  <c:v>59.673055664812111</c:v>
                </c:pt>
                <c:pt idx="51">
                  <c:v>58.776946255563978</c:v>
                </c:pt>
                <c:pt idx="52">
                  <c:v>58.31441756635072</c:v>
                </c:pt>
                <c:pt idx="53">
                  <c:v>58.758903094327152</c:v>
                </c:pt>
                <c:pt idx="54">
                  <c:v>60.937456925370881</c:v>
                </c:pt>
                <c:pt idx="55">
                  <c:v>59.77559043053698</c:v>
                </c:pt>
                <c:pt idx="56">
                  <c:v>59.558214080562443</c:v>
                </c:pt>
                <c:pt idx="57">
                  <c:v>59.55698905027549</c:v>
                </c:pt>
                <c:pt idx="58">
                  <c:v>59.172245225074349</c:v>
                </c:pt>
                <c:pt idx="59">
                  <c:v>57.591351957850158</c:v>
                </c:pt>
                <c:pt idx="60">
                  <c:v>58.206792171423082</c:v>
                </c:pt>
                <c:pt idx="61">
                  <c:v>59.585186135129732</c:v>
                </c:pt>
                <c:pt idx="62">
                  <c:v>58.894200948072367</c:v>
                </c:pt>
                <c:pt idx="63">
                  <c:v>55.245855422672811</c:v>
                </c:pt>
                <c:pt idx="64">
                  <c:v>58.240140060777073</c:v>
                </c:pt>
                <c:pt idx="65">
                  <c:v>57.648713365315658</c:v>
                </c:pt>
                <c:pt idx="66">
                  <c:v>57.897491768772518</c:v>
                </c:pt>
                <c:pt idx="67">
                  <c:v>57.553258044201101</c:v>
                </c:pt>
                <c:pt idx="68">
                  <c:v>56.873804029629618</c:v>
                </c:pt>
                <c:pt idx="69">
                  <c:v>57.34914104689156</c:v>
                </c:pt>
                <c:pt idx="70">
                  <c:v>58.014859630036369</c:v>
                </c:pt>
                <c:pt idx="71">
                  <c:v>57.112881809381413</c:v>
                </c:pt>
                <c:pt idx="72">
                  <c:v>57.723641192342498</c:v>
                </c:pt>
                <c:pt idx="73">
                  <c:v>55.591028494947857</c:v>
                </c:pt>
                <c:pt idx="74">
                  <c:v>55.512774971074798</c:v>
                </c:pt>
                <c:pt idx="75">
                  <c:v>53.371247828192118</c:v>
                </c:pt>
                <c:pt idx="76">
                  <c:v>57.03899838560794</c:v>
                </c:pt>
                <c:pt idx="77">
                  <c:v>56.462837903389001</c:v>
                </c:pt>
                <c:pt idx="78">
                  <c:v>56.20666962596632</c:v>
                </c:pt>
                <c:pt idx="79">
                  <c:v>56.800813939969103</c:v>
                </c:pt>
                <c:pt idx="80">
                  <c:v>56.045087289167711</c:v>
                </c:pt>
                <c:pt idx="81">
                  <c:v>56.734270636272107</c:v>
                </c:pt>
                <c:pt idx="82">
                  <c:v>56.801718645585652</c:v>
                </c:pt>
                <c:pt idx="83">
                  <c:v>54.082663904244043</c:v>
                </c:pt>
                <c:pt idx="84">
                  <c:v>55.348491830569102</c:v>
                </c:pt>
                <c:pt idx="85">
                  <c:v>56.052766703160152</c:v>
                </c:pt>
                <c:pt idx="86">
                  <c:v>56.102843056664483</c:v>
                </c:pt>
                <c:pt idx="87">
                  <c:v>54.737905640924851</c:v>
                </c:pt>
                <c:pt idx="88">
                  <c:v>55.532832650874141</c:v>
                </c:pt>
                <c:pt idx="89">
                  <c:v>54.557906467099407</c:v>
                </c:pt>
                <c:pt idx="90">
                  <c:v>54.384052584460427</c:v>
                </c:pt>
                <c:pt idx="91">
                  <c:v>54.884118414981458</c:v>
                </c:pt>
                <c:pt idx="92">
                  <c:v>54.488102328680561</c:v>
                </c:pt>
                <c:pt idx="93">
                  <c:v>54.689767657021292</c:v>
                </c:pt>
                <c:pt idx="94">
                  <c:v>56.718461914809453</c:v>
                </c:pt>
                <c:pt idx="95">
                  <c:v>53.52387261193854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5998176"/>
        <c:axId val="135998736"/>
      </c:areaChart>
      <c:catAx>
        <c:axId val="135998176"/>
        <c:scaling>
          <c:orientation val="minMax"/>
        </c:scaling>
        <c:delete val="1"/>
        <c:axPos val="b"/>
        <c:title>
          <c:tx>
            <c:rich>
              <a:bodyPr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000" b="1" i="0" u="none" strike="noStrike" kern="1200" baseline="0">
                    <a:solidFill>
                      <a:prstClr val="black"/>
                    </a:solidFill>
                    <a:latin typeface="Arial"/>
                    <a:ea typeface="+mn-ea"/>
                    <a:cs typeface="Arial"/>
                  </a:defRPr>
                </a:pPr>
                <a:r>
                  <a:rPr lang="en-US" sz="1200" b="1" i="0" baseline="0" dirty="0" smtClean="0">
                    <a:effectLst/>
                  </a:rPr>
                  <a:t>Different FANTOM5 cell types/tissues from ‘</a:t>
                </a:r>
                <a:r>
                  <a:rPr lang="en-US" sz="1200" b="1" i="0" baseline="0" dirty="0" smtClean="0">
                    <a:effectLst/>
                  </a:rPr>
                  <a:t>exclusively </a:t>
                </a:r>
                <a:r>
                  <a:rPr lang="en-US" sz="1200" b="1" i="0" baseline="0" dirty="0" smtClean="0">
                    <a:effectLst/>
                  </a:rPr>
                  <a:t>transcribed’ datasets</a:t>
                </a:r>
                <a:endParaRPr lang="en-US" sz="1200" dirty="0" smtClean="0">
                  <a:effectLst/>
                </a:endParaRPr>
              </a:p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000" b="1" i="0" u="none" strike="noStrike" kern="1200" baseline="0">
                    <a:solidFill>
                      <a:prstClr val="black"/>
                    </a:solidFill>
                    <a:latin typeface="Arial"/>
                    <a:ea typeface="+mn-ea"/>
                    <a:cs typeface="Arial"/>
                  </a:defRPr>
                </a:pPr>
                <a:endParaRPr lang="en-US" sz="1400" b="1" dirty="0">
                  <a:latin typeface="Arial"/>
                  <a:cs typeface="Arial"/>
                </a:endParaRPr>
              </a:p>
            </c:rich>
          </c:tx>
          <c:layout>
            <c:manualLayout>
              <c:xMode val="edge"/>
              <c:yMode val="edge"/>
              <c:x val="0.23002647201288701"/>
              <c:y val="0.85618145865251005"/>
            </c:manualLayout>
          </c:layout>
          <c:overlay val="0"/>
        </c:title>
        <c:numFmt formatCode="General" sourceLinked="0"/>
        <c:majorTickMark val="in"/>
        <c:minorTickMark val="none"/>
        <c:tickLblPos val="low"/>
        <c:crossAx val="135998736"/>
        <c:crosses val="autoZero"/>
        <c:auto val="1"/>
        <c:lblAlgn val="ctr"/>
        <c:lblOffset val="100"/>
        <c:noMultiLvlLbl val="0"/>
      </c:catAx>
      <c:valAx>
        <c:axId val="135998736"/>
        <c:scaling>
          <c:orientation val="minMax"/>
          <c:max val="10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1">
                    <a:latin typeface="Arial"/>
                    <a:cs typeface="Arial"/>
                  </a:defRPr>
                </a:pPr>
                <a:r>
                  <a:rPr lang="en-US" sz="1400" b="1" dirty="0" smtClean="0">
                    <a:latin typeface="Arial"/>
                    <a:cs typeface="Arial"/>
                  </a:rPr>
                  <a:t>Classification performance</a:t>
                </a:r>
                <a:r>
                  <a:rPr lang="en-US" sz="1400" b="1" baseline="0" dirty="0" smtClean="0">
                    <a:latin typeface="Arial"/>
                    <a:cs typeface="Arial"/>
                  </a:rPr>
                  <a:t> </a:t>
                </a:r>
                <a:r>
                  <a:rPr lang="en-US" sz="1400" b="1" baseline="0" dirty="0">
                    <a:latin typeface="Arial"/>
                    <a:cs typeface="Arial"/>
                  </a:rPr>
                  <a:t>(%)</a:t>
                </a:r>
                <a:endParaRPr lang="en-US" sz="1400" b="1" dirty="0">
                  <a:latin typeface="Arial"/>
                  <a:cs typeface="Arial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 rot="0" vert="horz"/>
          <a:lstStyle/>
          <a:p>
            <a:pPr>
              <a:defRPr sz="1400" b="1">
                <a:latin typeface="Arial"/>
                <a:cs typeface="Arial"/>
              </a:defRPr>
            </a:pPr>
            <a:endParaRPr lang="zh-CN"/>
          </a:p>
        </c:txPr>
        <c:crossAx val="135998176"/>
        <c:crosses val="autoZero"/>
        <c:crossBetween val="midCat"/>
        <c:majorUnit val="20"/>
        <c:minorUnit val="5"/>
      </c:valAx>
      <c:spPr>
        <a:noFill/>
        <a:ln>
          <a:noFill/>
        </a:ln>
      </c:spPr>
    </c:plotArea>
    <c:legend>
      <c:legendPos val="r"/>
      <c:layout>
        <c:manualLayout>
          <c:xMode val="edge"/>
          <c:yMode val="edge"/>
          <c:x val="0.74774616155813101"/>
          <c:y val="0.22945362881676001"/>
          <c:w val="0.13358588760095999"/>
          <c:h val="0.11273381551288"/>
        </c:manualLayout>
      </c:layout>
      <c:overlay val="0"/>
      <c:txPr>
        <a:bodyPr/>
        <a:lstStyle/>
        <a:p>
          <a:pPr>
            <a:defRPr sz="1400" b="1">
              <a:latin typeface="Arial"/>
              <a:cs typeface="Arial"/>
            </a:defRPr>
          </a:pPr>
          <a:endParaRPr lang="zh-CN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90367B-8AE8-124A-9857-94C89EF2017F}" type="datetimeFigureOut">
              <a:rPr lang="en-US" smtClean="0"/>
              <a:t>12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6D70A-DD31-B14A-B99A-6D413B4996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61282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90367B-8AE8-124A-9857-94C89EF2017F}" type="datetimeFigureOut">
              <a:rPr lang="en-US" smtClean="0"/>
              <a:t>12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6D70A-DD31-B14A-B99A-6D413B4996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19126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90367B-8AE8-124A-9857-94C89EF2017F}" type="datetimeFigureOut">
              <a:rPr lang="en-US" smtClean="0"/>
              <a:t>12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6D70A-DD31-B14A-B99A-6D413B4996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66740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90367B-8AE8-124A-9857-94C89EF2017F}" type="datetimeFigureOut">
              <a:rPr lang="en-US" smtClean="0"/>
              <a:t>12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6D70A-DD31-B14A-B99A-6D413B4996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4584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90367B-8AE8-124A-9857-94C89EF2017F}" type="datetimeFigureOut">
              <a:rPr lang="en-US" smtClean="0"/>
              <a:t>12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6D70A-DD31-B14A-B99A-6D413B4996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26364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90367B-8AE8-124A-9857-94C89EF2017F}" type="datetimeFigureOut">
              <a:rPr lang="en-US" smtClean="0"/>
              <a:t>12/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6D70A-DD31-B14A-B99A-6D413B4996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43201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90367B-8AE8-124A-9857-94C89EF2017F}" type="datetimeFigureOut">
              <a:rPr lang="en-US" smtClean="0"/>
              <a:t>12/9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6D70A-DD31-B14A-B99A-6D413B4996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23533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90367B-8AE8-124A-9857-94C89EF2017F}" type="datetimeFigureOut">
              <a:rPr lang="en-US" smtClean="0"/>
              <a:t>12/9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6D70A-DD31-B14A-B99A-6D413B4996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09591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90367B-8AE8-124A-9857-94C89EF2017F}" type="datetimeFigureOut">
              <a:rPr lang="en-US" smtClean="0"/>
              <a:t>12/9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6D70A-DD31-B14A-B99A-6D413B4996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01877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90367B-8AE8-124A-9857-94C89EF2017F}" type="datetimeFigureOut">
              <a:rPr lang="en-US" smtClean="0"/>
              <a:t>12/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6D70A-DD31-B14A-B99A-6D413B4996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50555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90367B-8AE8-124A-9857-94C89EF2017F}" type="datetimeFigureOut">
              <a:rPr lang="en-US" smtClean="0"/>
              <a:t>12/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6D70A-DD31-B14A-B99A-6D413B4996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40603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90367B-8AE8-124A-9857-94C89EF2017F}" type="datetimeFigureOut">
              <a:rPr lang="en-US" smtClean="0"/>
              <a:t>12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56D70A-DD31-B14A-B99A-6D413B4996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93298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68198124"/>
              </p:ext>
            </p:extLst>
          </p:nvPr>
        </p:nvGraphicFramePr>
        <p:xfrm>
          <a:off x="133350" y="622300"/>
          <a:ext cx="8877300" cy="5613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4444743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3</Words>
  <Application>Microsoft Office PowerPoint</Application>
  <PresentationFormat>全屏显示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演示文稿</vt:lpstr>
    </vt:vector>
  </TitlesOfParts>
  <Company>ICR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imitrios Kleftogiannis</dc:creator>
  <cp:lastModifiedBy>A</cp:lastModifiedBy>
  <cp:revision>6</cp:revision>
  <dcterms:created xsi:type="dcterms:W3CDTF">2018-02-26T16:04:47Z</dcterms:created>
  <dcterms:modified xsi:type="dcterms:W3CDTF">2018-12-09T07:43:26Z</dcterms:modified>
</cp:coreProperties>
</file>